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9144000" cy="6858000" type="screen4x3"/>
  <p:notesSz cx="6858000" cy="9083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00"/>
    <a:srgbClr val="0000FF"/>
    <a:srgbClr val="8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96" autoAdjust="0"/>
    <p:restoredTop sz="93188" autoAdjust="0"/>
  </p:normalViewPr>
  <p:slideViewPr>
    <p:cSldViewPr>
      <p:cViewPr varScale="1">
        <p:scale>
          <a:sx n="109" d="100"/>
          <a:sy n="109" d="100"/>
        </p:scale>
        <p:origin x="-27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72421" cy="454494"/>
          </a:xfrm>
          <a:prstGeom prst="rect">
            <a:avLst/>
          </a:prstGeom>
        </p:spPr>
        <p:txBody>
          <a:bodyPr vert="horz" lIns="89381" tIns="44690" rIns="89381" bIns="4469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027" y="1"/>
            <a:ext cx="2972421" cy="454494"/>
          </a:xfrm>
          <a:prstGeom prst="rect">
            <a:avLst/>
          </a:prstGeom>
        </p:spPr>
        <p:txBody>
          <a:bodyPr vert="horz" lIns="89381" tIns="44690" rIns="89381" bIns="44690" rtlCol="0"/>
          <a:lstStyle>
            <a:lvl1pPr algn="r">
              <a:defRPr sz="1200"/>
            </a:lvl1pPr>
          </a:lstStyle>
          <a:p>
            <a:fld id="{C56FD694-0CA5-4845-8E52-67349938595D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57288" y="681038"/>
            <a:ext cx="4543425" cy="34067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381" tIns="44690" rIns="89381" bIns="4469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6421" y="4315368"/>
            <a:ext cx="5485158" cy="4087344"/>
          </a:xfrm>
          <a:prstGeom prst="rect">
            <a:avLst/>
          </a:prstGeom>
        </p:spPr>
        <p:txBody>
          <a:bodyPr vert="horz" lIns="89381" tIns="44690" rIns="89381" bIns="4469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8627630"/>
            <a:ext cx="2972421" cy="454494"/>
          </a:xfrm>
          <a:prstGeom prst="rect">
            <a:avLst/>
          </a:prstGeom>
        </p:spPr>
        <p:txBody>
          <a:bodyPr vert="horz" lIns="89381" tIns="44690" rIns="89381" bIns="4469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027" y="8627630"/>
            <a:ext cx="2972421" cy="454494"/>
          </a:xfrm>
          <a:prstGeom prst="rect">
            <a:avLst/>
          </a:prstGeom>
        </p:spPr>
        <p:txBody>
          <a:bodyPr vert="horz" lIns="89381" tIns="44690" rIns="89381" bIns="44690" rtlCol="0" anchor="b"/>
          <a:lstStyle>
            <a:lvl1pPr algn="r">
              <a:defRPr sz="1200"/>
            </a:lvl1pPr>
          </a:lstStyle>
          <a:p>
            <a:fld id="{020301D7-DBB4-498A-A0D5-5C1A4B85C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6737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0301D7-DBB4-498A-A0D5-5C1A4B85CF5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1999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248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415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57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607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480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886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277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816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559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129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773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1AAA11-4B5B-4653-8A22-05E8CAA76730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FD09B-4573-4DE1-9CCC-99604038F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208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2228850" y="1261646"/>
            <a:ext cx="4686300" cy="5372100"/>
            <a:chOff x="2228850" y="742950"/>
            <a:chExt cx="4686300" cy="5372100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28850" y="742950"/>
              <a:ext cx="4686300" cy="5372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2" name="Straight Connector 11"/>
            <p:cNvCxnSpPr/>
            <p:nvPr/>
          </p:nvCxnSpPr>
          <p:spPr>
            <a:xfrm>
              <a:off x="2527479" y="3328116"/>
              <a:ext cx="430017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/>
          <p:cNvSpPr txBox="1"/>
          <p:nvPr/>
        </p:nvSpPr>
        <p:spPr>
          <a:xfrm>
            <a:off x="76200" y="76200"/>
            <a:ext cx="8610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l Figure 2:  Comparison of QFI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using amplification loci in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TBP (119 bp) and FTH1 (119 bp). 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 subset of sixty-two (62) FFPE samples representing all six cancer types described in the primary study were assessed using both TBP and a second gene target,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ferritin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heavy polypeptid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1 (FTH1).  A Pearson correlation of 0.88 and a slope of 1.0 was observed between the QFI values determined for these two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genes,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reflecting strong agreement.  None of the samples with a QFI&gt;3% had a fold change &lt;0.5 or &gt;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2.0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onsistent with a lack of a significant copy number amplification or deletion in one or the other loci.  The 95% CI of fold change in QFI was 0.8-1.04. 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016967" y="6595646"/>
            <a:ext cx="13211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% QFI—FTH1 </a:t>
            </a:r>
            <a:endParaRPr lang="en-US" sz="16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1331170" y="2439085"/>
            <a:ext cx="12121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% QFI—TBP 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4005747" y="1280186"/>
            <a:ext cx="13324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00FF"/>
                </a:solidFill>
              </a:rPr>
              <a:t>Slope = 1.01</a:t>
            </a:r>
          </a:p>
          <a:p>
            <a:r>
              <a:rPr lang="en-US" dirty="0" smtClean="0">
                <a:solidFill>
                  <a:srgbClr val="0000FF"/>
                </a:solidFill>
              </a:rPr>
              <a:t>R = 0.88</a:t>
            </a:r>
            <a:endParaRPr lang="en-US" dirty="0">
              <a:solidFill>
                <a:srgbClr val="0000FF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759369" y="4981233"/>
            <a:ext cx="22912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old Change (FTH1/TBP)  </a:t>
            </a:r>
            <a:endParaRPr lang="en-US" sz="1600" dirty="0"/>
          </a:p>
        </p:txBody>
      </p:sp>
      <p:sp>
        <p:nvSpPr>
          <p:cNvPr id="18" name="TextBox 17"/>
          <p:cNvSpPr txBox="1"/>
          <p:nvPr/>
        </p:nvSpPr>
        <p:spPr>
          <a:xfrm>
            <a:off x="3886200" y="3947696"/>
            <a:ext cx="1899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CC0000"/>
                </a:solidFill>
              </a:rPr>
              <a:t>95% CI (0.80-1.04)</a:t>
            </a:r>
            <a:endParaRPr lang="en-US" dirty="0">
              <a:solidFill>
                <a:srgbClr val="CC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4916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25</TotalTime>
  <Words>155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sura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in Sah</dc:creator>
  <cp:lastModifiedBy>Gary Latham</cp:lastModifiedBy>
  <cp:revision>118</cp:revision>
  <cp:lastPrinted>2013-05-14T18:28:40Z</cp:lastPrinted>
  <dcterms:created xsi:type="dcterms:W3CDTF">2013-03-12T20:57:31Z</dcterms:created>
  <dcterms:modified xsi:type="dcterms:W3CDTF">2013-07-23T23:07:33Z</dcterms:modified>
</cp:coreProperties>
</file>